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>
        <p:scale>
          <a:sx n="68" d="100"/>
          <a:sy n="68" d="100"/>
        </p:scale>
        <p:origin x="1782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2" Type="http://schemas.openxmlformats.org/officeDocument/2006/relationships/image" Target="../media/image12.emf"/><Relationship Id="rId1" Type="http://schemas.openxmlformats.org/officeDocument/2006/relationships/image" Target="../media/image11.emf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05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137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077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956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993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169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963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574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372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5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543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DC3A9-B375-4F56-A95F-C84BB5A6E8FF}" type="datetimeFigureOut">
              <a:rPr lang="en-US" smtClean="0"/>
              <a:t>5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1D4A54-68EB-40EC-996A-30A7475ABE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848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oleObject" Target="../embeddings/oleObject14.bin"/><Relationship Id="rId18" Type="http://schemas.openxmlformats.org/officeDocument/2006/relationships/image" Target="../media/image16.emf"/><Relationship Id="rId3" Type="http://schemas.openxmlformats.org/officeDocument/2006/relationships/oleObject" Target="../embeddings/oleObject11.bin"/><Relationship Id="rId21" Type="http://schemas.openxmlformats.org/officeDocument/2006/relationships/image" Target="../media/image23.png"/><Relationship Id="rId7" Type="http://schemas.openxmlformats.org/officeDocument/2006/relationships/oleObject" Target="../embeddings/oleObject13.bin"/><Relationship Id="rId12" Type="http://schemas.openxmlformats.org/officeDocument/2006/relationships/image" Target="../media/image22.tif"/><Relationship Id="rId17" Type="http://schemas.openxmlformats.org/officeDocument/2006/relationships/oleObject" Target="../embeddings/oleObject16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5.emf"/><Relationship Id="rId20" Type="http://schemas.openxmlformats.org/officeDocument/2006/relationships/image" Target="../media/image17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12.emf"/><Relationship Id="rId11" Type="http://schemas.openxmlformats.org/officeDocument/2006/relationships/image" Target="../media/image21.tif"/><Relationship Id="rId5" Type="http://schemas.openxmlformats.org/officeDocument/2006/relationships/oleObject" Target="../embeddings/oleObject12.bin"/><Relationship Id="rId15" Type="http://schemas.openxmlformats.org/officeDocument/2006/relationships/oleObject" Target="../embeddings/oleObject15.bin"/><Relationship Id="rId23" Type="http://schemas.openxmlformats.org/officeDocument/2006/relationships/image" Target="../media/image18.emf"/><Relationship Id="rId10" Type="http://schemas.openxmlformats.org/officeDocument/2006/relationships/image" Target="../media/image20.tif"/><Relationship Id="rId19" Type="http://schemas.openxmlformats.org/officeDocument/2006/relationships/oleObject" Target="../embeddings/oleObject17.bin"/><Relationship Id="rId4" Type="http://schemas.openxmlformats.org/officeDocument/2006/relationships/image" Target="../media/image11.emf"/><Relationship Id="rId9" Type="http://schemas.openxmlformats.org/officeDocument/2006/relationships/image" Target="../media/image19.tif"/><Relationship Id="rId14" Type="http://schemas.openxmlformats.org/officeDocument/2006/relationships/image" Target="../media/image14.emf"/><Relationship Id="rId22" Type="http://schemas.openxmlformats.org/officeDocument/2006/relationships/oleObject" Target="../embeddings/oleObject1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9EB3C2D8-E7CC-497C-9C7B-3917C9F48E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7800069"/>
              </p:ext>
            </p:extLst>
          </p:nvPr>
        </p:nvGraphicFramePr>
        <p:xfrm>
          <a:off x="363360" y="3768300"/>
          <a:ext cx="1593241" cy="22907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3" name="Prism 9" r:id="rId3" imgW="3186481" imgH="4581520" progId="Prism9.Document">
                  <p:embed/>
                </p:oleObj>
              </mc:Choice>
              <mc:Fallback>
                <p:oleObj name="Prism 9" r:id="rId3" imgW="3186481" imgH="4581520" progId="Prism9.Document">
                  <p:embed/>
                  <p:pic>
                    <p:nvPicPr>
                      <p:cNvPr id="68" name="Object 67">
                        <a:extLst>
                          <a:ext uri="{FF2B5EF4-FFF2-40B4-BE49-F238E27FC236}">
                            <a16:creationId xmlns:a16="http://schemas.microsoft.com/office/drawing/2014/main" id="{EC560646-C715-4FB2-98F4-359AAE7876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3360" y="3768300"/>
                        <a:ext cx="1593241" cy="22907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9C9FB5DB-58F0-4F8E-866F-E2CEA364B462}"/>
              </a:ext>
            </a:extLst>
          </p:cNvPr>
          <p:cNvSpPr txBox="1"/>
          <p:nvPr/>
        </p:nvSpPr>
        <p:spPr>
          <a:xfrm>
            <a:off x="37872" y="183163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K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A90DFD5-9A53-44B2-8DDC-615F9745EC58}"/>
              </a:ext>
            </a:extLst>
          </p:cNvPr>
          <p:cNvSpPr txBox="1"/>
          <p:nvPr/>
        </p:nvSpPr>
        <p:spPr>
          <a:xfrm>
            <a:off x="-9417" y="4507414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KT</a:t>
            </a:r>
          </a:p>
        </p:txBody>
      </p:sp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C71612EE-44E4-48C6-B43A-EE528B185C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4631747"/>
              </p:ext>
            </p:extLst>
          </p:nvPr>
        </p:nvGraphicFramePr>
        <p:xfrm>
          <a:off x="3383280" y="3768300"/>
          <a:ext cx="1593961" cy="22907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4" name="Prism 9" r:id="rId5" imgW="3187921" imgH="4581520" progId="Prism9.Document">
                  <p:embed/>
                </p:oleObj>
              </mc:Choice>
              <mc:Fallback>
                <p:oleObj name="Prism 9" r:id="rId5" imgW="3187921" imgH="4581520" progId="Prism9.Document">
                  <p:embed/>
                  <p:pic>
                    <p:nvPicPr>
                      <p:cNvPr id="67" name="Object 66">
                        <a:extLst>
                          <a:ext uri="{FF2B5EF4-FFF2-40B4-BE49-F238E27FC236}">
                            <a16:creationId xmlns:a16="http://schemas.microsoft.com/office/drawing/2014/main" id="{2C384EDB-B623-4B90-801D-28861B5A121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83280" y="3768300"/>
                        <a:ext cx="1593961" cy="22907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CDC82958-82E3-429B-886A-079ABE4852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3265757"/>
              </p:ext>
            </p:extLst>
          </p:nvPr>
        </p:nvGraphicFramePr>
        <p:xfrm>
          <a:off x="363360" y="1073694"/>
          <a:ext cx="1568751" cy="22907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5" name="Prism 9" r:id="rId7" imgW="3137502" imgH="4581520" progId="Prism9.Document">
                  <p:embed/>
                </p:oleObj>
              </mc:Choice>
              <mc:Fallback>
                <p:oleObj name="Prism 9" r:id="rId7" imgW="3137502" imgH="4581520" progId="Prism9.Document">
                  <p:embed/>
                  <p:pic>
                    <p:nvPicPr>
                      <p:cNvPr id="69" name="Object 68">
                        <a:extLst>
                          <a:ext uri="{FF2B5EF4-FFF2-40B4-BE49-F238E27FC236}">
                            <a16:creationId xmlns:a16="http://schemas.microsoft.com/office/drawing/2014/main" id="{22918AB3-557F-4619-9618-73A9739AD8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63360" y="1073694"/>
                        <a:ext cx="1568751" cy="22907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01549931-6164-43C1-965C-EA6A738778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8001663"/>
              </p:ext>
            </p:extLst>
          </p:nvPr>
        </p:nvGraphicFramePr>
        <p:xfrm>
          <a:off x="3383280" y="1069848"/>
          <a:ext cx="1596302" cy="22907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6" name="Prism 9" r:id="rId9" imgW="3192603" imgH="4581520" progId="Prism9.Document">
                  <p:embed/>
                </p:oleObj>
              </mc:Choice>
              <mc:Fallback>
                <p:oleObj name="Prism 9" r:id="rId9" imgW="3192603" imgH="4581520" progId="Prism9.Document">
                  <p:embed/>
                  <p:pic>
                    <p:nvPicPr>
                      <p:cNvPr id="70" name="Object 69">
                        <a:extLst>
                          <a:ext uri="{FF2B5EF4-FFF2-40B4-BE49-F238E27FC236}">
                            <a16:creationId xmlns:a16="http://schemas.microsoft.com/office/drawing/2014/main" id="{4F5002D5-0F6D-4E87-80D1-1B40A93A1C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383280" y="1069848"/>
                        <a:ext cx="1596302" cy="22907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30D2EEA7-58F1-40E9-B3C2-BC0E5D3A3B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5437874"/>
              </p:ext>
            </p:extLst>
          </p:nvPr>
        </p:nvGraphicFramePr>
        <p:xfrm>
          <a:off x="1833616" y="3768300"/>
          <a:ext cx="1593241" cy="22907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7" name="Prism 9" r:id="rId11" imgW="3186481" imgH="4581520" progId="Prism9.Document">
                  <p:embed/>
                </p:oleObj>
              </mc:Choice>
              <mc:Fallback>
                <p:oleObj name="Prism 9" r:id="rId11" imgW="3186481" imgH="4581520" progId="Prism9.Document">
                  <p:embed/>
                  <p:pic>
                    <p:nvPicPr>
                      <p:cNvPr id="76" name="Object 75">
                        <a:extLst>
                          <a:ext uri="{FF2B5EF4-FFF2-40B4-BE49-F238E27FC236}">
                            <a16:creationId xmlns:a16="http://schemas.microsoft.com/office/drawing/2014/main" id="{EF629AED-0F60-4165-901A-C0968572E4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833616" y="3768300"/>
                        <a:ext cx="1593241" cy="22907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048A77D3-5FC8-4CEF-83EE-B2A1B9E205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33600"/>
              </p:ext>
            </p:extLst>
          </p:nvPr>
        </p:nvGraphicFramePr>
        <p:xfrm>
          <a:off x="4937760" y="3768300"/>
          <a:ext cx="1593961" cy="22907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8" name="Prism 9" r:id="rId13" imgW="3187921" imgH="4581520" progId="Prism9.Document">
                  <p:embed/>
                </p:oleObj>
              </mc:Choice>
              <mc:Fallback>
                <p:oleObj name="Prism 9" r:id="rId13" imgW="3187921" imgH="4581520" progId="Prism9.Document">
                  <p:embed/>
                  <p:pic>
                    <p:nvPicPr>
                      <p:cNvPr id="77" name="Object 76">
                        <a:extLst>
                          <a:ext uri="{FF2B5EF4-FFF2-40B4-BE49-F238E27FC236}">
                            <a16:creationId xmlns:a16="http://schemas.microsoft.com/office/drawing/2014/main" id="{E3D49948-4941-47E2-938D-D0F8F5ADB0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937760" y="3768300"/>
                        <a:ext cx="1593961" cy="22907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CF051BDA-1EE4-4E22-9EE7-D22A2E4B17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7940875"/>
              </p:ext>
            </p:extLst>
          </p:nvPr>
        </p:nvGraphicFramePr>
        <p:xfrm>
          <a:off x="4937760" y="1069848"/>
          <a:ext cx="1632856" cy="22907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9" name="Prism 9" r:id="rId15" imgW="3265711" imgH="4581520" progId="Prism9.Document">
                  <p:embed/>
                </p:oleObj>
              </mc:Choice>
              <mc:Fallback>
                <p:oleObj name="Prism 9" r:id="rId15" imgW="3265711" imgH="4581520" progId="Prism9.Document">
                  <p:embed/>
                  <p:pic>
                    <p:nvPicPr>
                      <p:cNvPr id="78" name="Object 77">
                        <a:extLst>
                          <a:ext uri="{FF2B5EF4-FFF2-40B4-BE49-F238E27FC236}">
                            <a16:creationId xmlns:a16="http://schemas.microsoft.com/office/drawing/2014/main" id="{678C491C-2659-4548-9AC6-30662C85E9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937760" y="1069848"/>
                        <a:ext cx="1632856" cy="22907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097730FC-0191-4BEC-A30E-908B6585D3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7071142"/>
              </p:ext>
            </p:extLst>
          </p:nvPr>
        </p:nvGraphicFramePr>
        <p:xfrm>
          <a:off x="1833616" y="1069848"/>
          <a:ext cx="1596302" cy="22907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0" name="Prism 9" r:id="rId17" imgW="3192603" imgH="4581520" progId="Prism9.Document">
                  <p:embed/>
                </p:oleObj>
              </mc:Choice>
              <mc:Fallback>
                <p:oleObj name="Prism 9" r:id="rId17" imgW="3192603" imgH="4581520" progId="Prism9.Document">
                  <p:embed/>
                  <p:pic>
                    <p:nvPicPr>
                      <p:cNvPr id="79" name="Object 78">
                        <a:extLst>
                          <a:ext uri="{FF2B5EF4-FFF2-40B4-BE49-F238E27FC236}">
                            <a16:creationId xmlns:a16="http://schemas.microsoft.com/office/drawing/2014/main" id="{88039238-B663-4243-A9C6-3F14F20F89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833616" y="1069848"/>
                        <a:ext cx="1596302" cy="22907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28">
            <a:extLst>
              <a:ext uri="{FF2B5EF4-FFF2-40B4-BE49-F238E27FC236}">
                <a16:creationId xmlns:a16="http://schemas.microsoft.com/office/drawing/2014/main" id="{3C9A90A6-2E67-472D-97D2-0180DF4FC12C}"/>
              </a:ext>
            </a:extLst>
          </p:cNvPr>
          <p:cNvSpPr txBox="1"/>
          <p:nvPr/>
        </p:nvSpPr>
        <p:spPr>
          <a:xfrm>
            <a:off x="908422" y="731520"/>
            <a:ext cx="10477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ymph Nod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D02E4E6-2287-481C-BE1A-EE77FC9705F5}"/>
              </a:ext>
            </a:extLst>
          </p:cNvPr>
          <p:cNvSpPr txBox="1"/>
          <p:nvPr/>
        </p:nvSpPr>
        <p:spPr>
          <a:xfrm>
            <a:off x="2486119" y="731520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CC10B9C-8D9B-4193-9681-582E45401295}"/>
              </a:ext>
            </a:extLst>
          </p:cNvPr>
          <p:cNvSpPr txBox="1"/>
          <p:nvPr/>
        </p:nvSpPr>
        <p:spPr>
          <a:xfrm>
            <a:off x="3816011" y="731520"/>
            <a:ext cx="10477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ymph Nod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20B6C3B-6959-47EF-B76F-561339A4F62C}"/>
              </a:ext>
            </a:extLst>
          </p:cNvPr>
          <p:cNvSpPr txBox="1"/>
          <p:nvPr/>
        </p:nvSpPr>
        <p:spPr>
          <a:xfrm>
            <a:off x="5518357" y="731520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FC45316-3E12-4501-81EA-93CD6178CF94}"/>
              </a:ext>
            </a:extLst>
          </p:cNvPr>
          <p:cNvSpPr txBox="1"/>
          <p:nvPr/>
        </p:nvSpPr>
        <p:spPr>
          <a:xfrm>
            <a:off x="1554420" y="457200"/>
            <a:ext cx="1080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ranzyme B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1FD62D8-1162-4946-ADF0-D48FE309BE0D}"/>
              </a:ext>
            </a:extLst>
          </p:cNvPr>
          <p:cNvSpPr txBox="1"/>
          <p:nvPr/>
        </p:nvSpPr>
        <p:spPr>
          <a:xfrm>
            <a:off x="4626090" y="457200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58F8B5E-9C7D-4764-822E-1B31E6EEBBFF}"/>
              </a:ext>
            </a:extLst>
          </p:cNvPr>
          <p:cNvSpPr txBox="1"/>
          <p:nvPr/>
        </p:nvSpPr>
        <p:spPr>
          <a:xfrm>
            <a:off x="0" y="2743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A03711C-71EB-4598-8857-DD5E0FAF3042}"/>
              </a:ext>
            </a:extLst>
          </p:cNvPr>
          <p:cNvSpPr txBox="1"/>
          <p:nvPr/>
        </p:nvSpPr>
        <p:spPr>
          <a:xfrm>
            <a:off x="3291840" y="2743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90BB6E6-23AA-40DE-A9DB-7B25D9C23FF9}"/>
              </a:ext>
            </a:extLst>
          </p:cNvPr>
          <p:cNvSpPr txBox="1"/>
          <p:nvPr/>
        </p:nvSpPr>
        <p:spPr>
          <a:xfrm>
            <a:off x="-4013" y="333836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E250414-36EE-406A-AE73-47DFF681F128}"/>
              </a:ext>
            </a:extLst>
          </p:cNvPr>
          <p:cNvSpPr txBox="1"/>
          <p:nvPr/>
        </p:nvSpPr>
        <p:spPr>
          <a:xfrm>
            <a:off x="3287827" y="333836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B867A53-A80D-44B9-84D3-C4D8213E7D77}"/>
              </a:ext>
            </a:extLst>
          </p:cNvPr>
          <p:cNvSpPr txBox="1"/>
          <p:nvPr/>
        </p:nvSpPr>
        <p:spPr>
          <a:xfrm>
            <a:off x="904409" y="3639159"/>
            <a:ext cx="10477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ymph Nod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C003D5C-4527-4B14-8588-F0F49C1DFF88}"/>
              </a:ext>
            </a:extLst>
          </p:cNvPr>
          <p:cNvSpPr txBox="1"/>
          <p:nvPr/>
        </p:nvSpPr>
        <p:spPr>
          <a:xfrm>
            <a:off x="2482106" y="3639159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F998778-9B18-499D-8969-C24DC9309800}"/>
              </a:ext>
            </a:extLst>
          </p:cNvPr>
          <p:cNvSpPr txBox="1"/>
          <p:nvPr/>
        </p:nvSpPr>
        <p:spPr>
          <a:xfrm>
            <a:off x="3811998" y="3639159"/>
            <a:ext cx="10477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ymph Nod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871B49A-7921-46B2-AF31-98DFF5E0726D}"/>
              </a:ext>
            </a:extLst>
          </p:cNvPr>
          <p:cNvSpPr txBox="1"/>
          <p:nvPr/>
        </p:nvSpPr>
        <p:spPr>
          <a:xfrm>
            <a:off x="5514344" y="3639159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8A984E0-80AB-4697-A46E-6E83ED0E42CD}"/>
              </a:ext>
            </a:extLst>
          </p:cNvPr>
          <p:cNvSpPr txBox="1"/>
          <p:nvPr/>
        </p:nvSpPr>
        <p:spPr>
          <a:xfrm>
            <a:off x="1550407" y="3364839"/>
            <a:ext cx="10807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ranzyme B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AB58464-33E1-4479-904F-5F5DEFBDE00C}"/>
              </a:ext>
            </a:extLst>
          </p:cNvPr>
          <p:cNvSpPr txBox="1"/>
          <p:nvPr/>
        </p:nvSpPr>
        <p:spPr>
          <a:xfrm>
            <a:off x="4622077" y="3364839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37730F5-B8C9-4126-A29F-B0AFD03ADA93}"/>
              </a:ext>
            </a:extLst>
          </p:cNvPr>
          <p:cNvSpPr txBox="1"/>
          <p:nvPr/>
        </p:nvSpPr>
        <p:spPr>
          <a:xfrm>
            <a:off x="248944" y="6296703"/>
            <a:ext cx="628277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(A-D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w cytometric analysis of Granzyme B and IFN</a:t>
            </a:r>
            <a:r>
              <a:rPr lang="el-GR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γ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duction by NK and NKT cells. Graph shows average percentages of (A)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zmb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NK cells, (B) IFN-γ+ NK cells, (C) 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zmb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NKT cells, and (D) IFN-γ+ NKT cells in draining lymph nodes and spleens of cancer induced and control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t1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/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t1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/-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ce (n=15-17 cancer induced mice per group). * p-value &lt; 0.05; ** p-value &lt; 0.01; *** p-value &lt; 0.001 between group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sz="12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07ED87A-0539-4E2B-9504-9202E42853FE}"/>
              </a:ext>
            </a:extLst>
          </p:cNvPr>
          <p:cNvSpPr txBox="1"/>
          <p:nvPr/>
        </p:nvSpPr>
        <p:spPr>
          <a:xfrm>
            <a:off x="11304" y="28857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8200061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EAB5137-14C1-461D-8615-323943F069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057407"/>
              </p:ext>
            </p:extLst>
          </p:nvPr>
        </p:nvGraphicFramePr>
        <p:xfrm>
          <a:off x="1225550" y="487363"/>
          <a:ext cx="3751263" cy="297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4" name="Prism 9" r:id="rId3" imgW="3750971" imgH="2977868" progId="Prism9.Document">
                  <p:embed/>
                </p:oleObj>
              </mc:Choice>
              <mc:Fallback>
                <p:oleObj name="Prism 9" r:id="rId3" imgW="3750971" imgH="297786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25550" y="487363"/>
                        <a:ext cx="3751263" cy="297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10BAA84-0136-4101-AD0F-4C62C50125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1242846"/>
              </p:ext>
            </p:extLst>
          </p:nvPr>
        </p:nvGraphicFramePr>
        <p:xfrm>
          <a:off x="1119188" y="3514725"/>
          <a:ext cx="3860800" cy="297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5" name="Prism 9" r:id="rId5" imgW="3860743" imgH="2977868" progId="Prism9.Document">
                  <p:embed/>
                </p:oleObj>
              </mc:Choice>
              <mc:Fallback>
                <p:oleObj name="Prism 9" r:id="rId5" imgW="3860743" imgH="297786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19188" y="3514725"/>
                        <a:ext cx="3860800" cy="297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E93836C-F40D-4184-AD45-A12095064DCF}"/>
              </a:ext>
            </a:extLst>
          </p:cNvPr>
          <p:cNvSpPr txBox="1"/>
          <p:nvPr/>
        </p:nvSpPr>
        <p:spPr>
          <a:xfrm>
            <a:off x="764358" y="543002"/>
            <a:ext cx="2698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439763E-4319-4D44-A581-A6F5755918F4}"/>
              </a:ext>
            </a:extLst>
          </p:cNvPr>
          <p:cNvSpPr txBox="1"/>
          <p:nvPr/>
        </p:nvSpPr>
        <p:spPr>
          <a:xfrm>
            <a:off x="764358" y="3465586"/>
            <a:ext cx="2698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F0ED939-1BE1-4654-8E00-7C43ADB466F6}"/>
              </a:ext>
            </a:extLst>
          </p:cNvPr>
          <p:cNvSpPr txBox="1"/>
          <p:nvPr/>
        </p:nvSpPr>
        <p:spPr>
          <a:xfrm>
            <a:off x="22608" y="8418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8977E10-A1BB-4772-8C08-92E6652508C1}"/>
              </a:ext>
            </a:extLst>
          </p:cNvPr>
          <p:cNvSpPr txBox="1"/>
          <p:nvPr/>
        </p:nvSpPr>
        <p:spPr>
          <a:xfrm>
            <a:off x="351692" y="6388145"/>
            <a:ext cx="618002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Mutation rate observed in tumor tissue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rom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tat1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/+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(WT) and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tat1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ice orthotopically injected with LY2 HNSCC cells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number of point mutations (A) and Insertion–deletion mutations (B) detected in each RNA-seq sample, was scaled by sequencing depth. No significant differences were observed between 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T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nd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tat1</a:t>
            </a:r>
            <a:r>
              <a:rPr lang="en-US" sz="1200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ic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2881586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112054F-29C6-4F47-A5BB-A494A9358153}"/>
              </a:ext>
            </a:extLst>
          </p:cNvPr>
          <p:cNvGrpSpPr/>
          <p:nvPr/>
        </p:nvGrpSpPr>
        <p:grpSpPr>
          <a:xfrm>
            <a:off x="84433" y="592239"/>
            <a:ext cx="6773567" cy="3746728"/>
            <a:chOff x="7835" y="2445102"/>
            <a:chExt cx="6773567" cy="3746728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D9C14AD-BD51-48CF-9504-B493B1C5DCF8}"/>
                </a:ext>
              </a:extLst>
            </p:cNvPr>
            <p:cNvSpPr txBox="1"/>
            <p:nvPr/>
          </p:nvSpPr>
          <p:spPr>
            <a:xfrm>
              <a:off x="936845" y="2551844"/>
              <a:ext cx="55459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Ki67                             MCM3                           BCL2                           CASP8 </a:t>
              </a:r>
            </a:p>
          </p:txBody>
        </p:sp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D71DF97B-8C1B-4EAB-8EDB-0197C842E8D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79113161"/>
                </p:ext>
              </p:extLst>
            </p:nvPr>
          </p:nvGraphicFramePr>
          <p:xfrm>
            <a:off x="2463858" y="4617880"/>
            <a:ext cx="1142711" cy="15711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2" name="Prism 9" r:id="rId3" imgW="2285422" imgH="3142385" progId="Prism9.Document">
                    <p:embed/>
                  </p:oleObj>
                </mc:Choice>
                <mc:Fallback>
                  <p:oleObj name="Prism 9" r:id="rId3" imgW="2285422" imgH="314238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463858" y="4617880"/>
                          <a:ext cx="1142711" cy="157119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07588007-2DD2-44F3-BC38-F46ECCBD75C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99229158"/>
                </p:ext>
              </p:extLst>
            </p:nvPr>
          </p:nvGraphicFramePr>
          <p:xfrm>
            <a:off x="1457371" y="4625857"/>
            <a:ext cx="1074148" cy="156597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3" name="Prism 9" r:id="rId5" imgW="2148296" imgH="3131945" progId="Prism9.Document">
                    <p:embed/>
                  </p:oleObj>
                </mc:Choice>
                <mc:Fallback>
                  <p:oleObj name="Prism 9" r:id="rId5" imgW="2148296" imgH="3131945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457371" y="4625857"/>
                          <a:ext cx="1074148" cy="156597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DFB06DD7-5AC7-40B8-9987-9F774CD6899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13820352"/>
                </p:ext>
              </p:extLst>
            </p:nvPr>
          </p:nvGraphicFramePr>
          <p:xfrm>
            <a:off x="3485859" y="4495122"/>
            <a:ext cx="1074148" cy="169395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4" name="Prism 9" r:id="rId7" imgW="2148296" imgH="3387901" progId="Prism9.Document">
                    <p:embed/>
                  </p:oleObj>
                </mc:Choice>
                <mc:Fallback>
                  <p:oleObj name="Prism 9" r:id="rId7" imgW="2148296" imgH="3387901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485859" y="4495122"/>
                          <a:ext cx="1074148" cy="169395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C516D9BF-89AD-4471-A33D-424A111AD7A6}"/>
                </a:ext>
              </a:extLst>
            </p:cNvPr>
            <p:cNvGrpSpPr/>
            <p:nvPr/>
          </p:nvGrpSpPr>
          <p:grpSpPr>
            <a:xfrm>
              <a:off x="7835" y="4710703"/>
              <a:ext cx="1561026" cy="1309769"/>
              <a:chOff x="2448609" y="3900624"/>
              <a:chExt cx="1561026" cy="1309769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B56468C6-1A42-4B25-A6C9-BBCDCABCF69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866" t="31810" r="42203" b="64445"/>
              <a:stretch/>
            </p:blipFill>
            <p:spPr>
              <a:xfrm>
                <a:off x="3178810" y="4935855"/>
                <a:ext cx="694944" cy="1787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E8BBD00F-D9BE-467C-A8B1-442D1B1964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6555" r="67887" b="19615"/>
              <a:stretch/>
            </p:blipFill>
            <p:spPr>
              <a:xfrm>
                <a:off x="3178810" y="4707177"/>
                <a:ext cx="694944" cy="1828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2ED80102-BC35-4DCC-9D2D-E291C78D54E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768" r="32301" b="23548"/>
              <a:stretch/>
            </p:blipFill>
            <p:spPr>
              <a:xfrm>
                <a:off x="3178810" y="4246977"/>
                <a:ext cx="692161" cy="1828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26FAC849-8183-4FB0-BF8E-512ACC4088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265" t="6479" r="5595" b="-6482"/>
              <a:stretch/>
            </p:blipFill>
            <p:spPr>
              <a:xfrm>
                <a:off x="3178810" y="4478655"/>
                <a:ext cx="694944" cy="1828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664A46FD-BBCA-48FD-BF68-8D19208C222B}"/>
                  </a:ext>
                </a:extLst>
              </p:cNvPr>
              <p:cNvGrpSpPr/>
              <p:nvPr/>
            </p:nvGrpSpPr>
            <p:grpSpPr>
              <a:xfrm>
                <a:off x="2448609" y="3900624"/>
                <a:ext cx="1561026" cy="1309769"/>
                <a:chOff x="217590" y="4361608"/>
                <a:chExt cx="1561026" cy="1309769"/>
              </a:xfrm>
            </p:grpSpPr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E1142A11-3EF9-4688-A886-440703C13B36}"/>
                    </a:ext>
                  </a:extLst>
                </p:cNvPr>
                <p:cNvSpPr txBox="1"/>
                <p:nvPr/>
              </p:nvSpPr>
              <p:spPr>
                <a:xfrm>
                  <a:off x="217590" y="4586593"/>
                  <a:ext cx="793611" cy="10847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lnSpc>
                      <a:spcPts val="2000"/>
                    </a:lnSpc>
                  </a:pPr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I67</a:t>
                  </a:r>
                </a:p>
                <a:p>
                  <a:pPr algn="ctr">
                    <a:lnSpc>
                      <a:spcPts val="2000"/>
                    </a:lnSpc>
                  </a:pPr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CM3</a:t>
                  </a:r>
                </a:p>
                <a:p>
                  <a:pPr algn="ctr">
                    <a:lnSpc>
                      <a:spcPts val="2000"/>
                    </a:lnSpc>
                  </a:pPr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CL2</a:t>
                  </a:r>
                </a:p>
                <a:p>
                  <a:pPr algn="ctr">
                    <a:lnSpc>
                      <a:spcPts val="2000"/>
                    </a:lnSpc>
                  </a:pPr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PDH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FD0917AF-7E64-4674-8775-7FE0A758CDA7}"/>
                    </a:ext>
                  </a:extLst>
                </p:cNvPr>
                <p:cNvSpPr txBox="1"/>
                <p:nvPr/>
              </p:nvSpPr>
              <p:spPr>
                <a:xfrm>
                  <a:off x="383607" y="4361608"/>
                  <a:ext cx="1395009" cy="35182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Stat1    </a:t>
                  </a:r>
                  <a:r>
                    <a:rPr lang="en-US" sz="12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  -  +  -</a:t>
                  </a:r>
                </a:p>
                <a:p>
                  <a:pPr>
                    <a:lnSpc>
                      <a:spcPts val="10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im24    </a:t>
                  </a:r>
                  <a:r>
                    <a:rPr lang="en-US" sz="12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  +  -  -</a:t>
                  </a:r>
                </a:p>
              </p:txBody>
            </p:sp>
          </p:grpSp>
        </p:grpSp>
        <p:graphicFrame>
          <p:nvGraphicFramePr>
            <p:cNvPr id="41" name="Object 40">
              <a:extLst>
                <a:ext uri="{FF2B5EF4-FFF2-40B4-BE49-F238E27FC236}">
                  <a16:creationId xmlns:a16="http://schemas.microsoft.com/office/drawing/2014/main" id="{B02DBAF8-4130-48A8-A42F-11E21AF2153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21066755"/>
                </p:ext>
              </p:extLst>
            </p:nvPr>
          </p:nvGraphicFramePr>
          <p:xfrm>
            <a:off x="236437" y="2742066"/>
            <a:ext cx="1634167" cy="166641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5" name="Prism 9" r:id="rId13" imgW="3268333" imgH="3332822" progId="Prism9.Document">
                    <p:embed/>
                  </p:oleObj>
                </mc:Choice>
                <mc:Fallback>
                  <p:oleObj name="Prism 9" r:id="rId13" imgW="3268333" imgH="3332822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36437" y="2742066"/>
                          <a:ext cx="1634167" cy="166641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2" name="Object 41">
              <a:extLst>
                <a:ext uri="{FF2B5EF4-FFF2-40B4-BE49-F238E27FC236}">
                  <a16:creationId xmlns:a16="http://schemas.microsoft.com/office/drawing/2014/main" id="{75BAD984-0F08-42EA-9DD8-89E47D4D020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4190580"/>
                </p:ext>
              </p:extLst>
            </p:nvPr>
          </p:nvGraphicFramePr>
          <p:xfrm>
            <a:off x="1798792" y="2762031"/>
            <a:ext cx="1630208" cy="166641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6" name="Prism 9" r:id="rId15" imgW="3260415" imgH="3332822" progId="Prism9.Document">
                    <p:embed/>
                  </p:oleObj>
                </mc:Choice>
                <mc:Fallback>
                  <p:oleObj name="Prism 9" r:id="rId15" imgW="3260415" imgH="3332822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1798792" y="2762031"/>
                          <a:ext cx="1630208" cy="166641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3" name="Object 42">
              <a:extLst>
                <a:ext uri="{FF2B5EF4-FFF2-40B4-BE49-F238E27FC236}">
                  <a16:creationId xmlns:a16="http://schemas.microsoft.com/office/drawing/2014/main" id="{046EB9A6-2B9E-4CFC-8E32-EEA04AAF167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88277210"/>
                </p:ext>
              </p:extLst>
            </p:nvPr>
          </p:nvGraphicFramePr>
          <p:xfrm>
            <a:off x="3385560" y="2762030"/>
            <a:ext cx="1634167" cy="166641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7" name="Prism 9" r:id="rId17" imgW="3268333" imgH="3332822" progId="Prism9.Document">
                    <p:embed/>
                  </p:oleObj>
                </mc:Choice>
                <mc:Fallback>
                  <p:oleObj name="Prism 9" r:id="rId17" imgW="3268333" imgH="3332822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3385560" y="2762030"/>
                          <a:ext cx="1634167" cy="166641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4" name="Object 43">
              <a:extLst>
                <a:ext uri="{FF2B5EF4-FFF2-40B4-BE49-F238E27FC236}">
                  <a16:creationId xmlns:a16="http://schemas.microsoft.com/office/drawing/2014/main" id="{16726E88-E7FF-453C-B5F5-0B598317423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61927094"/>
                </p:ext>
              </p:extLst>
            </p:nvPr>
          </p:nvGraphicFramePr>
          <p:xfrm>
            <a:off x="4943956" y="2743670"/>
            <a:ext cx="1630208" cy="170313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48" name="Prism 9" r:id="rId19" imgW="3260415" imgH="3406260" progId="Prism9.Document">
                    <p:embed/>
                  </p:oleObj>
                </mc:Choice>
                <mc:Fallback>
                  <p:oleObj name="Prism 9" r:id="rId19" imgW="3260415" imgH="340626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4943956" y="2743670"/>
                          <a:ext cx="1630208" cy="170313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873BA69C-1252-4471-B7FB-C40EA4A948A7}"/>
                </a:ext>
              </a:extLst>
            </p:cNvPr>
            <p:cNvGrpSpPr/>
            <p:nvPr/>
          </p:nvGrpSpPr>
          <p:grpSpPr>
            <a:xfrm>
              <a:off x="4660308" y="4669078"/>
              <a:ext cx="2121094" cy="1454158"/>
              <a:chOff x="4180593" y="4304334"/>
              <a:chExt cx="2121094" cy="1454158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D844ADD0-97DB-4561-AB62-3375B193BFC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10847" t="3119" r="4267" b="25015"/>
              <a:stretch/>
            </p:blipFill>
            <p:spPr>
              <a:xfrm>
                <a:off x="4180593" y="4421440"/>
                <a:ext cx="1293824" cy="1170125"/>
              </a:xfrm>
              <a:prstGeom prst="rect">
                <a:avLst/>
              </a:prstGeom>
            </p:spPr>
          </p:pic>
          <p:graphicFrame>
            <p:nvGraphicFramePr>
              <p:cNvPr id="20" name="Object 19">
                <a:extLst>
                  <a:ext uri="{FF2B5EF4-FFF2-40B4-BE49-F238E27FC236}">
                    <a16:creationId xmlns:a16="http://schemas.microsoft.com/office/drawing/2014/main" id="{A72338BF-97B5-4828-B574-540B2E7A3A0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929969521"/>
                  </p:ext>
                </p:extLst>
              </p:nvPr>
            </p:nvGraphicFramePr>
            <p:xfrm>
              <a:off x="5413720" y="4304334"/>
              <a:ext cx="887967" cy="137157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149" name="Prism 9" r:id="rId22" imgW="2219918" imgH="3428940" progId="Prism9.Document">
                      <p:embed/>
                    </p:oleObj>
                  </mc:Choice>
                  <mc:Fallback>
                    <p:oleObj name="Prism 9" r:id="rId22" imgW="2219918" imgH="3428940" progId="Prism9.Document">
                      <p:embed/>
                      <p:pic>
                        <p:nvPicPr>
                          <p:cNvPr id="10" name="Object 9">
                            <a:extLst>
                              <a:ext uri="{FF2B5EF4-FFF2-40B4-BE49-F238E27FC236}">
                                <a16:creationId xmlns:a16="http://schemas.microsoft.com/office/drawing/2014/main" id="{AF11C7FF-0F98-4EEB-A0FD-2AFC4A7ABFD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3"/>
                          <a:stretch>
                            <a:fillRect/>
                          </a:stretch>
                        </p:blipFill>
                        <p:spPr>
                          <a:xfrm>
                            <a:off x="5413720" y="4304334"/>
                            <a:ext cx="887967" cy="1371576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F7A055F8-6D0A-4F48-BB88-196EDD4F698F}"/>
                  </a:ext>
                </a:extLst>
              </p:cNvPr>
              <p:cNvGrpSpPr/>
              <p:nvPr/>
            </p:nvGrpSpPr>
            <p:grpSpPr>
              <a:xfrm>
                <a:off x="4377017" y="4377623"/>
                <a:ext cx="908764" cy="437782"/>
                <a:chOff x="15309007" y="11825285"/>
                <a:chExt cx="908764" cy="437782"/>
              </a:xfrm>
            </p:grpSpPr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A5268D23-370D-4D63-A1CB-298FEE83FCA7}"/>
                    </a:ext>
                  </a:extLst>
                </p:cNvPr>
                <p:cNvSpPr txBox="1"/>
                <p:nvPr/>
              </p:nvSpPr>
              <p:spPr>
                <a:xfrm>
                  <a:off x="15326842" y="11986068"/>
                  <a:ext cx="87083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US" sz="12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im24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8ABB158F-9D71-4DC5-8CA0-88FDF5E2DACF}"/>
                    </a:ext>
                  </a:extLst>
                </p:cNvPr>
                <p:cNvSpPr txBox="1"/>
                <p:nvPr/>
              </p:nvSpPr>
              <p:spPr>
                <a:xfrm>
                  <a:off x="15346938" y="11825285"/>
                  <a:ext cx="87083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sz="12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im24</a:t>
                  </a:r>
                </a:p>
              </p:txBody>
            </p:sp>
            <p:sp>
              <p:nvSpPr>
                <p:cNvPr id="26" name="Rectangle 25">
                  <a:extLst>
                    <a:ext uri="{FF2B5EF4-FFF2-40B4-BE49-F238E27FC236}">
                      <a16:creationId xmlns:a16="http://schemas.microsoft.com/office/drawing/2014/main" id="{708A1300-30B0-481B-8CC1-3DD34946F562}"/>
                    </a:ext>
                  </a:extLst>
                </p:cNvPr>
                <p:cNvSpPr/>
                <p:nvPr/>
              </p:nvSpPr>
              <p:spPr>
                <a:xfrm>
                  <a:off x="15309007" y="11921060"/>
                  <a:ext cx="91440" cy="91440"/>
                </a:xfrm>
                <a:prstGeom prst="rect">
                  <a:avLst/>
                </a:prstGeom>
                <a:noFill/>
                <a:ln w="19050">
                  <a:solidFill>
                    <a:srgbClr val="FF99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dirty="0"/>
                </a:p>
              </p:txBody>
            </p:sp>
            <p:sp>
              <p:nvSpPr>
                <p:cNvPr id="27" name="Rectangle 26">
                  <a:extLst>
                    <a:ext uri="{FF2B5EF4-FFF2-40B4-BE49-F238E27FC236}">
                      <a16:creationId xmlns:a16="http://schemas.microsoft.com/office/drawing/2014/main" id="{D7D96ED2-FB73-460E-8E17-324E1EDCFD9D}"/>
                    </a:ext>
                  </a:extLst>
                </p:cNvPr>
                <p:cNvSpPr/>
                <p:nvPr/>
              </p:nvSpPr>
              <p:spPr>
                <a:xfrm>
                  <a:off x="15309007" y="12077848"/>
                  <a:ext cx="91440" cy="91440"/>
                </a:xfrm>
                <a:prstGeom prst="rect">
                  <a:avLst/>
                </a:prstGeom>
                <a:noFill/>
                <a:ln w="19050">
                  <a:solidFill>
                    <a:srgbClr val="0017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dirty="0"/>
                </a:p>
              </p:txBody>
            </p:sp>
          </p:grp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089D467E-3149-40D4-B9C2-E568666FE12B}"/>
                  </a:ext>
                </a:extLst>
              </p:cNvPr>
              <p:cNvSpPr txBox="1"/>
              <p:nvPr/>
            </p:nvSpPr>
            <p:spPr>
              <a:xfrm>
                <a:off x="4616382" y="5481493"/>
                <a:ext cx="9952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STAT1</a:t>
                </a:r>
              </a:p>
            </p:txBody>
          </p:sp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id="{4E6B3B01-2E69-4163-8461-2EC507942A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11412" y="5637295"/>
                <a:ext cx="365760" cy="0"/>
              </a:xfrm>
              <a:prstGeom prst="straightConnector1">
                <a:avLst/>
              </a:prstGeom>
              <a:ln w="12700"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CD02067-4B5B-40D6-AE71-D53F169B22FB}"/>
                </a:ext>
              </a:extLst>
            </p:cNvPr>
            <p:cNvSpPr txBox="1"/>
            <p:nvPr/>
          </p:nvSpPr>
          <p:spPr>
            <a:xfrm>
              <a:off x="40645" y="2445102"/>
              <a:ext cx="2698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BF368A2-A7A6-4BB9-B371-A37406898BE4}"/>
                </a:ext>
              </a:extLst>
            </p:cNvPr>
            <p:cNvSpPr txBox="1"/>
            <p:nvPr/>
          </p:nvSpPr>
          <p:spPr>
            <a:xfrm>
              <a:off x="40645" y="4318080"/>
              <a:ext cx="2698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E94D5AD-4ADC-4673-8CEA-4D7C93C6AAA7}"/>
                </a:ext>
              </a:extLst>
            </p:cNvPr>
            <p:cNvSpPr txBox="1"/>
            <p:nvPr/>
          </p:nvSpPr>
          <p:spPr>
            <a:xfrm>
              <a:off x="4484596" y="4408477"/>
              <a:ext cx="2698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6454D028-1DA8-4D5D-8AE9-F023EE4CB906}"/>
              </a:ext>
            </a:extLst>
          </p:cNvPr>
          <p:cNvSpPr txBox="1"/>
          <p:nvPr/>
        </p:nvSpPr>
        <p:spPr>
          <a:xfrm>
            <a:off x="22608" y="8418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DF85A4E-3F51-49B2-8511-BB6F5A78308F}"/>
              </a:ext>
            </a:extLst>
          </p:cNvPr>
          <p:cNvSpPr txBox="1"/>
          <p:nvPr/>
        </p:nvSpPr>
        <p:spPr>
          <a:xfrm>
            <a:off x="131239" y="4469735"/>
            <a:ext cx="628277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(A,B) (A) Gene and (B) protein expression of Ki67, Mcm3, Bcl2, and Casp8, determined by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TqPCR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Western blot in siRNA-treated UMSCC22A cells at 48 or 72 hours. (C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TAT1 phosphorylation in CAL27 cells treated with scramble or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rim2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siRNA for 72 hours, determined by flow cytometry. Statistical significance (p&lt;0.05) in comparison to a)</a:t>
            </a:r>
            <a:r>
              <a:rPr lang="en-US" sz="12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tat1+Trim24,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) -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tat1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rim2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and c) +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tat1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rim2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is noted above each group (n=5 replicates per group for RTPCT and 3 replicates per group for Western blot)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485335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</TotalTime>
  <Words>355</Words>
  <Application>Microsoft Office PowerPoint</Application>
  <PresentationFormat>Letter Paper (8.5x11 in)</PresentationFormat>
  <Paragraphs>39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Oghumu</dc:creator>
  <cp:lastModifiedBy>Steve Oghumu</cp:lastModifiedBy>
  <cp:revision>12</cp:revision>
  <dcterms:created xsi:type="dcterms:W3CDTF">2022-03-07T03:15:37Z</dcterms:created>
  <dcterms:modified xsi:type="dcterms:W3CDTF">2022-05-01T04:00:23Z</dcterms:modified>
</cp:coreProperties>
</file>